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0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8/07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8/07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5496" y="5375105"/>
            <a:ext cx="729932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Yau and Ghislain et al (2025) Diabetologia DOI 10.1007/s00125-025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499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z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Recent developments in the role of the beta cell in the early pathogenesis, progression and remission of type 2 diabetes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C815516-A096-F03C-B3F8-96AC0A3A9EE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08712" y="1214777"/>
            <a:ext cx="5126576" cy="44284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7</cp:revision>
  <dcterms:created xsi:type="dcterms:W3CDTF">2016-06-15T12:53:43Z</dcterms:created>
  <dcterms:modified xsi:type="dcterms:W3CDTF">2025-07-28T13:54:06Z</dcterms:modified>
</cp:coreProperties>
</file>